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4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638251" y="1447764"/>
            <a:ext cx="5904688" cy="3999222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189911" y="113517"/>
            <a:ext cx="8207298" cy="52396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upplemental Figure S3.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ignificant gene sets related to drug based on the GLAD4U database enriched by CAD-associated genes identified from Sherlock Bayesian analysis</a:t>
            </a:r>
            <a:endParaRPr lang="zh-CN" altLang="en-US" sz="14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6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mbria Math</vt:lpstr>
      <vt:lpstr>Malgun Gothic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马云龙</cp:lastModifiedBy>
  <cp:revision>115</cp:revision>
  <dcterms:created xsi:type="dcterms:W3CDTF">2019-09-01T03:13:00Z</dcterms:created>
  <dcterms:modified xsi:type="dcterms:W3CDTF">2020-12-16T08:30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